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E6E892-FE6C-4E2A-81CD-5FB14CECFE41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0399C-B7E1-4B92-8A5D-731112DD6685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Frontiers\deseq2_exp1_23_7_21\Gráficas16_9_21\BoxPlotsCounts\qPCR\AUXIAA9.jpe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0"/>
            <a:ext cx="8640000" cy="5888001"/>
          </a:xfrm>
          <a:prstGeom prst="rect">
            <a:avLst/>
          </a:prstGeom>
          <a:noFill/>
        </p:spPr>
      </p:pic>
      <p:sp>
        <p:nvSpPr>
          <p:cNvPr id="3" name="2 CuadroTexto"/>
          <p:cNvSpPr txBox="1"/>
          <p:nvPr/>
        </p:nvSpPr>
        <p:spPr>
          <a:xfrm>
            <a:off x="179512" y="602128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 Figure S4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AUX/IAA9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(LOC111997593) gene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Juveni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and CR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tur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normaliz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ount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Stringtie2-DESeq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lativ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alu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0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us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feren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erimen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827584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5040000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4000" y="0"/>
            <a:ext cx="8640000" cy="58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2 CuadroTexto"/>
          <p:cNvSpPr txBox="1"/>
          <p:nvPr/>
        </p:nvSpPr>
        <p:spPr>
          <a:xfrm>
            <a:off x="179512" y="602128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 Figure S4B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AUX/IAA16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(LOC112037338) gene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Juveni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and CR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tur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normaliz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ount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Stringtie2-DESeq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lativ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alu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0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us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feren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erimen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827584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5040000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4000" y="0"/>
            <a:ext cx="8640000" cy="58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2 CuadroTexto"/>
          <p:cNvSpPr txBox="1"/>
          <p:nvPr/>
        </p:nvSpPr>
        <p:spPr>
          <a:xfrm>
            <a:off x="179512" y="602128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 Figure S4C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RAP2.12-like 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(LOC112039229) gene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Juveni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and CR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tur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normaliz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ount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Stringtie2-DESeq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lativ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alu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0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us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feren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erimen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827584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5040000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4000" y="0"/>
            <a:ext cx="8640000" cy="58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2 CuadroTexto"/>
          <p:cNvSpPr txBox="1"/>
          <p:nvPr/>
        </p:nvSpPr>
        <p:spPr>
          <a:xfrm>
            <a:off x="179512" y="602128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 Figure S4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Short-</a:t>
            </a:r>
            <a:r>
              <a:rPr lang="es-ES" sz="1200" i="1" dirty="0" err="1">
                <a:latin typeface="Times New Roman" pitchFamily="18" charset="0"/>
                <a:cs typeface="Times New Roman" pitchFamily="18" charset="0"/>
              </a:rPr>
              <a:t>Root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 1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(LOC112031035) gene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Juveni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and CR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tur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normaliz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ount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Stringtie2-DESeq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lativ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alu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0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us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feren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erimen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827584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5112000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4000" y="0"/>
            <a:ext cx="8640000" cy="58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2 CuadroTexto"/>
          <p:cNvSpPr txBox="1"/>
          <p:nvPr/>
        </p:nvSpPr>
        <p:spPr>
          <a:xfrm>
            <a:off x="179512" y="602128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 Figure S4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UDP-</a:t>
            </a:r>
            <a:r>
              <a:rPr lang="es-ES" sz="1200" i="1" dirty="0" err="1">
                <a:latin typeface="Times New Roman" pitchFamily="18" charset="0"/>
                <a:cs typeface="Times New Roman" pitchFamily="18" charset="0"/>
              </a:rPr>
              <a:t>glycosyltranferase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 79B9 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(LOC112032441) gene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Juveni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and CR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tur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normaliz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ount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Stringtie2-DESeq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lativ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alu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0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us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feren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erimen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827584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5040000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4000" y="0"/>
            <a:ext cx="8640000" cy="58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3 CuadroTexto"/>
          <p:cNvSpPr txBox="1"/>
          <p:nvPr/>
        </p:nvSpPr>
        <p:spPr>
          <a:xfrm>
            <a:off x="179512" y="602128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 Figure S4F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 err="1">
                <a:latin typeface="Times New Roman" pitchFamily="18" charset="0"/>
                <a:cs typeface="Times New Roman" pitchFamily="18" charset="0"/>
              </a:rPr>
              <a:t>Early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 Nodulin-93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(LOC112027987) gene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Juveni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and CR (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tur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normaliz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ount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Stringtie2-DESeq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lativ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alu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BS02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amp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us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feren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perimen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827584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5040000" y="324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361</Words>
  <Application>Microsoft Office PowerPoint</Application>
  <PresentationFormat>On-screen Show (4:3)</PresentationFormat>
  <Paragraphs>1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44428400J</dc:creator>
  <cp:lastModifiedBy>MDPI</cp:lastModifiedBy>
  <cp:revision>6</cp:revision>
  <dcterms:created xsi:type="dcterms:W3CDTF">2022-04-04T14:24:56Z</dcterms:created>
  <dcterms:modified xsi:type="dcterms:W3CDTF">2022-12-13T07:21:48Z</dcterms:modified>
</cp:coreProperties>
</file>